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 varScale="1">
        <p:scale>
          <a:sx n="104" d="100"/>
          <a:sy n="104" d="100"/>
        </p:scale>
        <p:origin x="232" y="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315469-EF51-B642-A1F1-9DC5557079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A8EBD8-258C-084B-98C6-A7B8BB399D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7744AA-7D6C-4D43-87B7-AB17A1C5A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83EC28-F9D1-4048-9243-137F0FAB8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603AB2-18A7-424D-8DFF-43251FA934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18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9597CA-7B5A-F142-9654-726B8FDADD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C1DFE2-44E8-8D48-A96E-E2D61F6185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B9EE95-931D-8E4D-B0B7-F9FCC771A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E5833D-B035-444C-9193-F371A69BF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66E771-38CB-EA4F-AE5C-066E426A7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200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DF028E-95CB-8547-87C3-1A640BD47D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061665-2A90-264D-9E3A-DC3D2F3D23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AD6974-FBC9-9744-BA6D-8D84B69EA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CFDAAA-0186-FD4B-96F4-8B87DD6A5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45BC02-FE04-8549-8803-F47F16FDF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476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F40F7D-4D1F-F74D-96BE-E8419BBA72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5D77A3-C9BC-0A4B-82A2-235ADB0157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7772E6-850A-5745-9164-B56805668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947A1E-FF25-4346-B0EA-E6E7B79C7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BDC05E-D65B-CC45-BFC9-2399D66003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139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7FDB60-E49A-604A-98DA-4E9D64790D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9C955E-6978-0643-9E7E-8CE6DD348C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AD4C4-E498-594A-86DB-BF52845CF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03E293-F258-EC4F-A9C1-F3A895DE2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83F9BA-4BC0-9B46-BAA7-581B75608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258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052707-1028-D94A-8B66-E7F210148D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9E9B62-3B11-6644-81AC-93597B2A61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BFA9A9-A326-DC4F-93B4-91094C7A96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58A0BD-6F68-DC46-87B2-FCC376503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AF61AF-4C9F-6446-BDE8-D8E691571A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6626F8-344D-774A-B5FE-202F0753A1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426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AE55E5-7853-C94D-A937-45F917CAC5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6263B5-892D-014B-9DBE-8B884C1242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BF22655-A9D9-B842-A0C3-F8678EC941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0766265-8EB3-DE47-BC5F-0AD0C322DB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1EA1518-66A9-9049-BB07-7B51E62394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04C6861-6CCC-1D40-B11B-739D78A05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EB396D-6F92-FB41-B72A-2BD48D594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15DDFE-6ED7-B440-AC9C-B0B5D8B15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371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51ECCE-C408-0944-AB05-CF9169F928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F8A5F9-FAF5-4145-AC07-4C63C4ED4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FA10B4-8AF6-8F47-B48D-2B69D72BF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41B5E3B-4CE4-9D43-80F9-B743C510B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24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D0CE327-350A-E541-9590-29528FEC8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4A2768E-18E7-A147-AC15-2F6622A5B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780AF6D-C465-9545-84EF-C5DA1E5AA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326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A07506-8D5E-F942-B827-62CD033408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1CF366-B0D7-DE4A-919F-28F671C65B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81EC21-5A77-D94D-BFF2-37A4675DA9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92EFB8-370E-1046-9D9E-E182FBC5C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AC7464-9D03-BE42-B87C-86730DBDFE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815856-E2FE-1C41-BDBA-D1D9BA9E36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391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61C297-3BC9-F943-99B4-33C42E1608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E7DB83-E4EE-2E4C-917F-B49C17B4BC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01BAB4-971C-004A-B345-2262345509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E73AE4-A311-AF45-A198-9D949484A9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369F68-BACF-AF49-9AEB-81ACCC5F2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F0B6DE-DE96-5E4B-BE9A-1DEEBBF547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571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479893-3C8E-4842-A610-4560A949EB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30056D-9D24-7C41-BFF6-F067C9A581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BDBCF8-3A82-4A45-B1EA-B85CB9A26E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984504-CCFC-5B4D-8027-8761C39CED01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B13C88-C7B2-C548-8C81-6D2E7F6B32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707452-B9F3-5548-916D-10E041CA93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5F306-2D91-6948-8FFD-57A78E67F8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073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night sky&#10;&#10;Description automatically generated">
            <a:extLst>
              <a:ext uri="{FF2B5EF4-FFF2-40B4-BE49-F238E27FC236}">
                <a16:creationId xmlns:a16="http://schemas.microsoft.com/office/drawing/2014/main" id="{027B13BB-872A-AB4F-85EE-1F94BD7C2E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5051" y="879335"/>
            <a:ext cx="4524320" cy="6008583"/>
          </a:xfrm>
          <a:prstGeom prst="rect">
            <a:avLst/>
          </a:prstGeom>
        </p:spPr>
      </p:pic>
      <p:pic>
        <p:nvPicPr>
          <p:cNvPr id="6" name="Picture 5" descr="A group of jellyfish&#10;&#10;Description automatically generated with medium confidence">
            <a:extLst>
              <a:ext uri="{FF2B5EF4-FFF2-40B4-BE49-F238E27FC236}">
                <a16:creationId xmlns:a16="http://schemas.microsoft.com/office/drawing/2014/main" id="{A10A2D4E-C799-AA40-A995-98DC7FC6ED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879336"/>
            <a:ext cx="4524320" cy="600858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2D41237-575A-E14A-AA23-782F7BF38955}"/>
              </a:ext>
            </a:extLst>
          </p:cNvPr>
          <p:cNvSpPr txBox="1"/>
          <p:nvPr/>
        </p:nvSpPr>
        <p:spPr>
          <a:xfrm>
            <a:off x="1850917" y="450165"/>
            <a:ext cx="2546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-HCT116 no treatmen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CA9F250-A94F-904F-B9DA-BF5C5D513013}"/>
              </a:ext>
            </a:extLst>
          </p:cNvPr>
          <p:cNvSpPr txBox="1"/>
          <p:nvPr/>
        </p:nvSpPr>
        <p:spPr>
          <a:xfrm>
            <a:off x="6822927" y="480085"/>
            <a:ext cx="2279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-HCT116 </a:t>
            </a:r>
            <a:r>
              <a:rPr lang="en-US" dirty="0" err="1"/>
              <a:t>Dox+auxin</a:t>
            </a:r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4259855-2F01-AC4A-93EE-CB09873D458B}"/>
              </a:ext>
            </a:extLst>
          </p:cNvPr>
          <p:cNvSpPr/>
          <p:nvPr/>
        </p:nvSpPr>
        <p:spPr>
          <a:xfrm>
            <a:off x="1762145" y="3093775"/>
            <a:ext cx="2183130" cy="21331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459F4B3-69B6-B04F-B6E9-521C8F44B9F8}"/>
              </a:ext>
            </a:extLst>
          </p:cNvPr>
          <p:cNvSpPr/>
          <p:nvPr/>
        </p:nvSpPr>
        <p:spPr>
          <a:xfrm>
            <a:off x="7734578" y="2718205"/>
            <a:ext cx="2183130" cy="21331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808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9010A98-B08F-2447-AE81-5352F1F4E6B8}"/>
              </a:ext>
            </a:extLst>
          </p:cNvPr>
          <p:cNvSpPr txBox="1"/>
          <p:nvPr/>
        </p:nvSpPr>
        <p:spPr>
          <a:xfrm>
            <a:off x="1542066" y="526578"/>
            <a:ext cx="2448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treatmen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446BB7-3265-6E43-A34E-5897680ADA02}"/>
              </a:ext>
            </a:extLst>
          </p:cNvPr>
          <p:cNvSpPr txBox="1"/>
          <p:nvPr/>
        </p:nvSpPr>
        <p:spPr>
          <a:xfrm>
            <a:off x="7130750" y="556498"/>
            <a:ext cx="2181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</a:t>
            </a:r>
            <a:endParaRPr lang="en-US" dirty="0"/>
          </a:p>
        </p:txBody>
      </p:sp>
      <p:pic>
        <p:nvPicPr>
          <p:cNvPr id="4" name="Picture 3" descr="A group of jellyfish&#10;&#10;Description automatically generated with low confidence">
            <a:extLst>
              <a:ext uri="{FF2B5EF4-FFF2-40B4-BE49-F238E27FC236}">
                <a16:creationId xmlns:a16="http://schemas.microsoft.com/office/drawing/2014/main" id="{556401C8-C4BF-994B-A5D1-35FC21521B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2215" y="1025609"/>
            <a:ext cx="4391650" cy="5832389"/>
          </a:xfrm>
          <a:prstGeom prst="rect">
            <a:avLst/>
          </a:prstGeom>
        </p:spPr>
      </p:pic>
      <p:pic>
        <p:nvPicPr>
          <p:cNvPr id="11" name="Picture 10" descr="A picture containing jellyfish, coelenterate, dark, ocean floor&#10;&#10;Description automatically generated">
            <a:extLst>
              <a:ext uri="{FF2B5EF4-FFF2-40B4-BE49-F238E27FC236}">
                <a16:creationId xmlns:a16="http://schemas.microsoft.com/office/drawing/2014/main" id="{9E43CBBB-6D8E-4A4D-AF15-84F3F3CC36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25864" y="1025610"/>
            <a:ext cx="4391650" cy="5832389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9D385AE1-8688-174D-AA7A-1CEEBCA12A40}"/>
              </a:ext>
            </a:extLst>
          </p:cNvPr>
          <p:cNvSpPr/>
          <p:nvPr/>
        </p:nvSpPr>
        <p:spPr>
          <a:xfrm>
            <a:off x="1056787" y="4003589"/>
            <a:ext cx="2328963" cy="20713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1FE3186-3617-FD42-AD17-C871F9BAE9DB}"/>
              </a:ext>
            </a:extLst>
          </p:cNvPr>
          <p:cNvSpPr/>
          <p:nvPr/>
        </p:nvSpPr>
        <p:spPr>
          <a:xfrm>
            <a:off x="7573940" y="3286615"/>
            <a:ext cx="2183130" cy="213313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5943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AAECBE6-4D37-6849-9247-27C8252B745A}"/>
              </a:ext>
            </a:extLst>
          </p:cNvPr>
          <p:cNvSpPr txBox="1"/>
          <p:nvPr/>
        </p:nvSpPr>
        <p:spPr>
          <a:xfrm>
            <a:off x="1542066" y="526578"/>
            <a:ext cx="2448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5 no treatmen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1D1858-7299-DC49-A166-DF02AC8C8B90}"/>
              </a:ext>
            </a:extLst>
          </p:cNvPr>
          <p:cNvSpPr txBox="1"/>
          <p:nvPr/>
        </p:nvSpPr>
        <p:spPr>
          <a:xfrm>
            <a:off x="7130750" y="556498"/>
            <a:ext cx="2181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5 </a:t>
            </a:r>
            <a:r>
              <a:rPr lang="en-US" dirty="0" err="1"/>
              <a:t>Dox+auxin</a:t>
            </a:r>
            <a:endParaRPr lang="en-US" dirty="0"/>
          </a:p>
        </p:txBody>
      </p:sp>
      <p:pic>
        <p:nvPicPr>
          <p:cNvPr id="4" name="Picture 3" descr="A picture containing night sky&#10;&#10;Description automatically generated">
            <a:extLst>
              <a:ext uri="{FF2B5EF4-FFF2-40B4-BE49-F238E27FC236}">
                <a16:creationId xmlns:a16="http://schemas.microsoft.com/office/drawing/2014/main" id="{622EEB5F-4C98-794B-944B-67CC8D0C2E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1276" y="895908"/>
            <a:ext cx="4460701" cy="592409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B2D7D4F-4687-3F4C-B0CA-2ADC13D3BC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9233" y="895907"/>
            <a:ext cx="4460701" cy="5924093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05B302AB-85CB-134A-BBD9-0DD5F6C73132}"/>
              </a:ext>
            </a:extLst>
          </p:cNvPr>
          <p:cNvSpPr/>
          <p:nvPr/>
        </p:nvSpPr>
        <p:spPr>
          <a:xfrm>
            <a:off x="1742304" y="2273643"/>
            <a:ext cx="2335426" cy="229835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0272783-5779-9E48-B751-832EE82649F2}"/>
              </a:ext>
            </a:extLst>
          </p:cNvPr>
          <p:cNvSpPr/>
          <p:nvPr/>
        </p:nvSpPr>
        <p:spPr>
          <a:xfrm>
            <a:off x="7636476" y="1394719"/>
            <a:ext cx="2307699" cy="217638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9259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9</Words>
  <Application>Microsoft Macintosh PowerPoint</Application>
  <PresentationFormat>Widescreen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iang-Chen Chou</dc:creator>
  <cp:lastModifiedBy>Hsiang-Chen Chou</cp:lastModifiedBy>
  <cp:revision>1</cp:revision>
  <dcterms:created xsi:type="dcterms:W3CDTF">2021-01-26T03:39:30Z</dcterms:created>
  <dcterms:modified xsi:type="dcterms:W3CDTF">2021-01-26T03:50:01Z</dcterms:modified>
</cp:coreProperties>
</file>